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100" d="100"/>
          <a:sy n="100" d="100"/>
        </p:scale>
        <p:origin x="2574" y="123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0450E26-90C3-8E9C-FF38-CD1DF947281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FC4381F-A5D9-5D10-01BE-591D4EEE16F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E98C867-FCCF-9433-F17F-B5F04113C8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80CF7D-9A12-4D9A-95C2-BEB2F5BF7083}" type="datetimeFigureOut">
              <a:rPr lang="en-GB" smtClean="0"/>
              <a:t>20/05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35FF12B-2884-F3A6-93F5-0AFDB5533E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F87A9F3-B07E-E972-2E74-3117A803EB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3E78D1-4C41-4223-9CE6-B2945A80461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959367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BDC7B8E-77A7-8959-6A4B-45C9ECA5873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45875DA-11EF-7BB4-B2A4-53307808810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45BD067-73F5-EA3B-E145-8EA3AA1F4F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80CF7D-9A12-4D9A-95C2-BEB2F5BF7083}" type="datetimeFigureOut">
              <a:rPr lang="en-GB" smtClean="0"/>
              <a:t>20/05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B9F8249-2F4D-4266-2F9C-EB5058AFAE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A95A343-3C11-70EC-4609-B0E732E992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3E78D1-4C41-4223-9CE6-B2945A80461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449849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EF68ADA-965F-D8B1-1278-3D6EBBBF63B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D6C7B04-FD7A-4776-E31F-FC1AFE62251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0341778-D3B6-DAF6-14E0-5345EC186F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80CF7D-9A12-4D9A-95C2-BEB2F5BF7083}" type="datetimeFigureOut">
              <a:rPr lang="en-GB" smtClean="0"/>
              <a:t>20/05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8965BFE-7337-E3C5-4F0A-2AB54A3E67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621BBA8-7580-F7DA-A126-A19633F242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3E78D1-4C41-4223-9CE6-B2945A80461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0925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60A6BC6-A7C9-608F-D389-9FC5BEC7C64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B0D0F86-48BE-44DD-3641-B0B1B682371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4E687A9-C4B4-E4D3-1485-32BFC15780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80CF7D-9A12-4D9A-95C2-BEB2F5BF7083}" type="datetimeFigureOut">
              <a:rPr lang="en-GB" smtClean="0"/>
              <a:t>20/05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173308D-6F1A-F8E7-86A9-128EE7EEFF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1B80EAE-6C38-6FAF-7433-06602C29D0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3E78D1-4C41-4223-9CE6-B2945A80461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646719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9B35C75-3B47-E0C1-6A5C-42D701B4D5B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49CC9BC-7246-4BF5-5094-0CBAA4D3419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DA4AF13-3306-43C7-C095-0A56991B0F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80CF7D-9A12-4D9A-95C2-BEB2F5BF7083}" type="datetimeFigureOut">
              <a:rPr lang="en-GB" smtClean="0"/>
              <a:t>20/05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0BEC445-C63B-0971-EBCD-E643565809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4C9CDA7-B9A7-B993-6210-1746AF524F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3E78D1-4C41-4223-9CE6-B2945A80461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020518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FBFE4F8-57E8-09B3-53AC-A72D9BD6B95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451FA02-298C-3F7A-784E-B035756932F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B5EB669-E80A-5360-2FBB-FDD80618B8E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FF03F7D-3EC7-C1A3-26A5-FBB5A17A1D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80CF7D-9A12-4D9A-95C2-BEB2F5BF7083}" type="datetimeFigureOut">
              <a:rPr lang="en-GB" smtClean="0"/>
              <a:t>20/05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B355B42-C756-BAF9-BC18-9EF69B8C1D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A3B9ED9-8D51-B587-2B1D-94C2368C50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3E78D1-4C41-4223-9CE6-B2945A80461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849678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9DAEF4A-263B-C767-54EE-E952C3BDE99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06EE0B7-0C08-9F81-3919-1729EDA016E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D738806-1640-31FE-7840-B2D66BEF503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F522F08-C8E0-3348-28BC-2674B126AB6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BCEE43D-A4C9-8561-42A1-299B2985067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5477530-0682-EAC6-8A87-DA6EAE490B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80CF7D-9A12-4D9A-95C2-BEB2F5BF7083}" type="datetimeFigureOut">
              <a:rPr lang="en-GB" smtClean="0"/>
              <a:t>20/05/2024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2786C7E-C000-C525-39E4-202E57D1F2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6D1E7DF-1769-0A9C-0B55-453E527ECC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3E78D1-4C41-4223-9CE6-B2945A80461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05549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156B73-19C6-937E-11CF-CC675F8018D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BA174E6-FAE6-AA61-137C-2396FE5DF2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80CF7D-9A12-4D9A-95C2-BEB2F5BF7083}" type="datetimeFigureOut">
              <a:rPr lang="en-GB" smtClean="0"/>
              <a:t>20/05/2024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5FB0784-AE1A-598B-6F3E-175FE93543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98E45D7-354A-6B2C-AC2E-B89FC5CAAA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3E78D1-4C41-4223-9CE6-B2945A80461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4189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80C5E52-A548-5270-D0A4-DCFCC70832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80CF7D-9A12-4D9A-95C2-BEB2F5BF7083}" type="datetimeFigureOut">
              <a:rPr lang="en-GB" smtClean="0"/>
              <a:t>20/05/2024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28C5A45-8020-D2F5-AB89-B5757B6B3E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BA95B19-8035-4318-10C0-8C3F1B6B05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3E78D1-4C41-4223-9CE6-B2945A80461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55346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B9323B2-5ED2-A1A3-5894-832F1D0070B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80DA5D5-6D8D-2D63-B48C-576B8C2F2B5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C94747F-747B-801C-59BB-4EBE39E5627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3F30796-4BFF-9445-20BF-5A2EDE3C75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80CF7D-9A12-4D9A-95C2-BEB2F5BF7083}" type="datetimeFigureOut">
              <a:rPr lang="en-GB" smtClean="0"/>
              <a:t>20/05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776BDD8-BDD2-18FA-D947-220C3BFC74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61D3785-7606-1785-4227-97BAFA3BEA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3E78D1-4C41-4223-9CE6-B2945A80461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582181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9D17618-4176-3866-1099-1931285842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F6CDB4E-A5AF-9EAA-0D23-FE2589961A4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5C1483D-303B-DD7B-287A-CFF48498770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2C785CF-4680-170A-0EB7-E106341077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80CF7D-9A12-4D9A-95C2-BEB2F5BF7083}" type="datetimeFigureOut">
              <a:rPr lang="en-GB" smtClean="0"/>
              <a:t>20/05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6371F83-7921-0DE0-BDF5-FEA3940FD4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5BB894C-A8A7-AC92-3254-1A8CC9A7D1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3E78D1-4C41-4223-9CE6-B2945A80461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582423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178BC2F-92B9-E0CE-C59C-73B7ED9E7A0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21ADED9-A4BE-C452-02E1-343DA59E2D1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B48B024-5042-C9E4-8FF4-914195DECB3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380CF7D-9A12-4D9A-95C2-BEB2F5BF7083}" type="datetimeFigureOut">
              <a:rPr lang="en-GB" smtClean="0"/>
              <a:t>20/05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1E80437-01C0-9087-6740-5270C25D989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35BD53A-BF46-19B1-76E5-4338B45D460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53E78D1-4C41-4223-9CE6-B2945A80461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144368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jpg"/></Relationships>
</file>

<file path=ppt/slides/_rels/slide2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.jpeg"/><Relationship Id="rId5" Type="http://schemas.openxmlformats.org/officeDocument/2006/relationships/image" Target="../media/image6.jpeg"/><Relationship Id="rId4" Type="http://schemas.openxmlformats.org/officeDocument/2006/relationships/image" Target="../media/image5.jp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jpg"/><Relationship Id="rId2" Type="http://schemas.openxmlformats.org/officeDocument/2006/relationships/image" Target="../media/image8.jpe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0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3806062D-534E-6225-95DF-EACD01555DF5}"/>
              </a:ext>
            </a:extLst>
          </p:cNvPr>
          <p:cNvSpPr txBox="1"/>
          <p:nvPr/>
        </p:nvSpPr>
        <p:spPr>
          <a:xfrm>
            <a:off x="416597" y="2736221"/>
            <a:ext cx="105670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eLa-Cas9 Cells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6E547635-F1D4-6C0B-D2CC-5459AFA17764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0749" t="8189" r="33396" b="68522"/>
          <a:stretch/>
        </p:blipFill>
        <p:spPr>
          <a:xfrm rot="16200000">
            <a:off x="1040706" y="1441401"/>
            <a:ext cx="361335" cy="144534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98E1B73E-D9CB-BA0B-9384-5B6033A22F4E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0419" t="10729" r="31435" b="65795"/>
          <a:stretch/>
        </p:blipFill>
        <p:spPr>
          <a:xfrm rot="16200000">
            <a:off x="1040706" y="1842799"/>
            <a:ext cx="361335" cy="144534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80D1CB9F-A801-6825-1BD0-2515401F5FE9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8350" t="24255" r="22713" b="52848"/>
          <a:stretch/>
        </p:blipFill>
        <p:spPr>
          <a:xfrm rot="16200000">
            <a:off x="1040706" y="1039456"/>
            <a:ext cx="361335" cy="1445342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AA8D91B2-5FFC-BC6C-3275-D4F9F4C2F5CF}"/>
              </a:ext>
            </a:extLst>
          </p:cNvPr>
          <p:cNvSpPr txBox="1"/>
          <p:nvPr/>
        </p:nvSpPr>
        <p:spPr>
          <a:xfrm>
            <a:off x="1915468" y="1610870"/>
            <a:ext cx="655849" cy="2539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SP43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689D2C75-C94E-8C01-FA31-972AF6BD89A8}"/>
              </a:ext>
            </a:extLst>
          </p:cNvPr>
          <p:cNvSpPr txBox="1"/>
          <p:nvPr/>
        </p:nvSpPr>
        <p:spPr>
          <a:xfrm>
            <a:off x="1915467" y="2051868"/>
            <a:ext cx="528526" cy="2539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CA9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0F43AC89-B38F-A4D2-62F1-44FAAD4F498A}"/>
              </a:ext>
            </a:extLst>
          </p:cNvPr>
          <p:cNvSpPr txBox="1"/>
          <p:nvPr/>
        </p:nvSpPr>
        <p:spPr>
          <a:xfrm>
            <a:off x="1915467" y="2472793"/>
            <a:ext cx="599876" cy="2539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</a:p>
        </p:txBody>
      </p: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923ED450-BA0B-A9D4-43A7-F1CA57BCDAE2}"/>
              </a:ext>
            </a:extLst>
          </p:cNvPr>
          <p:cNvCxnSpPr>
            <a:cxnSpLocks/>
          </p:cNvCxnSpPr>
          <p:nvPr/>
        </p:nvCxnSpPr>
        <p:spPr>
          <a:xfrm>
            <a:off x="715675" y="1367142"/>
            <a:ext cx="498234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" name="TextBox 13">
            <a:extLst>
              <a:ext uri="{FF2B5EF4-FFF2-40B4-BE49-F238E27FC236}">
                <a16:creationId xmlns:a16="http://schemas.microsoft.com/office/drawing/2014/main" id="{19F9B2A3-D371-1E32-9049-4FF4F3B1C971}"/>
              </a:ext>
            </a:extLst>
          </p:cNvPr>
          <p:cNvSpPr txBox="1"/>
          <p:nvPr/>
        </p:nvSpPr>
        <p:spPr>
          <a:xfrm>
            <a:off x="595600" y="1171803"/>
            <a:ext cx="84537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SP43 KO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6AD9D239-B778-F12F-0595-D49BEC869DCD}"/>
              </a:ext>
            </a:extLst>
          </p:cNvPr>
          <p:cNvSpPr txBox="1"/>
          <p:nvPr/>
        </p:nvSpPr>
        <p:spPr>
          <a:xfrm>
            <a:off x="1286166" y="1175139"/>
            <a:ext cx="84537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SP43 KO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A86A3387-1825-AE7D-B0A2-09C2DFE7D772}"/>
              </a:ext>
            </a:extLst>
          </p:cNvPr>
          <p:cNvSpPr txBox="1"/>
          <p:nvPr/>
        </p:nvSpPr>
        <p:spPr>
          <a:xfrm>
            <a:off x="611565" y="953524"/>
            <a:ext cx="673935" cy="2539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21 % O</a:t>
            </a:r>
            <a:r>
              <a:rPr lang="en-GB" sz="9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964B3C7E-3C02-F135-85AB-25DA446FBDBB}"/>
              </a:ext>
            </a:extLst>
          </p:cNvPr>
          <p:cNvCxnSpPr>
            <a:cxnSpLocks/>
          </p:cNvCxnSpPr>
          <p:nvPr/>
        </p:nvCxnSpPr>
        <p:spPr>
          <a:xfrm flipV="1">
            <a:off x="512489" y="1166544"/>
            <a:ext cx="699769" cy="2153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17">
            <a:extLst>
              <a:ext uri="{FF2B5EF4-FFF2-40B4-BE49-F238E27FC236}">
                <a16:creationId xmlns:a16="http://schemas.microsoft.com/office/drawing/2014/main" id="{2389BC88-8ADF-5458-4C21-9C59A1A6F6D2}"/>
              </a:ext>
            </a:extLst>
          </p:cNvPr>
          <p:cNvSpPr txBox="1"/>
          <p:nvPr/>
        </p:nvSpPr>
        <p:spPr>
          <a:xfrm>
            <a:off x="1368660" y="953524"/>
            <a:ext cx="697893" cy="2539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 % O</a:t>
            </a:r>
            <a:r>
              <a:rPr lang="en-GB" sz="9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7A8A5488-C06A-D60D-9E9E-0F1278B0A6BE}"/>
              </a:ext>
            </a:extLst>
          </p:cNvPr>
          <p:cNvCxnSpPr>
            <a:cxnSpLocks/>
          </p:cNvCxnSpPr>
          <p:nvPr/>
        </p:nvCxnSpPr>
        <p:spPr>
          <a:xfrm flipV="1">
            <a:off x="1251900" y="1163204"/>
            <a:ext cx="699769" cy="2153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xtBox 19">
            <a:extLst>
              <a:ext uri="{FF2B5EF4-FFF2-40B4-BE49-F238E27FC236}">
                <a16:creationId xmlns:a16="http://schemas.microsoft.com/office/drawing/2014/main" id="{D35AFE6E-0575-AC32-8AFB-57AF186D2381}"/>
              </a:ext>
            </a:extLst>
          </p:cNvPr>
          <p:cNvSpPr txBox="1"/>
          <p:nvPr/>
        </p:nvSpPr>
        <p:spPr>
          <a:xfrm>
            <a:off x="1908909" y="1358943"/>
            <a:ext cx="98299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SP43 OE (µg)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AFEE0EF0-63DA-CD54-53D9-7C260420D328}"/>
              </a:ext>
            </a:extLst>
          </p:cNvPr>
          <p:cNvSpPr txBox="1"/>
          <p:nvPr/>
        </p:nvSpPr>
        <p:spPr>
          <a:xfrm>
            <a:off x="128628" y="1349864"/>
            <a:ext cx="428835" cy="2539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BF3C058F-B4A1-63A4-F4E4-5EE0245E818B}"/>
              </a:ext>
            </a:extLst>
          </p:cNvPr>
          <p:cNvCxnSpPr>
            <a:cxnSpLocks/>
          </p:cNvCxnSpPr>
          <p:nvPr/>
        </p:nvCxnSpPr>
        <p:spPr>
          <a:xfrm>
            <a:off x="1402127" y="1367142"/>
            <a:ext cx="498234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pSp>
        <p:nvGrpSpPr>
          <p:cNvPr id="23" name="Group 22">
            <a:extLst>
              <a:ext uri="{FF2B5EF4-FFF2-40B4-BE49-F238E27FC236}">
                <a16:creationId xmlns:a16="http://schemas.microsoft.com/office/drawing/2014/main" id="{ABD6BF0F-8915-8B73-3181-50CE1D99903F}"/>
              </a:ext>
            </a:extLst>
          </p:cNvPr>
          <p:cNvGrpSpPr/>
          <p:nvPr/>
        </p:nvGrpSpPr>
        <p:grpSpPr>
          <a:xfrm>
            <a:off x="490447" y="1361406"/>
            <a:ext cx="1495085" cy="253915"/>
            <a:chOff x="-2183319" y="4552336"/>
            <a:chExt cx="1587184" cy="253915"/>
          </a:xfrm>
        </p:grpSpPr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D5EFDA05-3737-B265-BE42-D7F02D8A681F}"/>
                </a:ext>
              </a:extLst>
            </p:cNvPr>
            <p:cNvSpPr txBox="1"/>
            <p:nvPr/>
          </p:nvSpPr>
          <p:spPr>
            <a:xfrm>
              <a:off x="-2183319" y="4552336"/>
              <a:ext cx="273665" cy="25391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39FD69FE-F4CB-6F84-15AA-885BCEE21CF3}"/>
                </a:ext>
              </a:extLst>
            </p:cNvPr>
            <p:cNvSpPr txBox="1"/>
            <p:nvPr/>
          </p:nvSpPr>
          <p:spPr>
            <a:xfrm>
              <a:off x="-2040413" y="4552336"/>
              <a:ext cx="273665" cy="25391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71AFC008-A2A6-69DA-E0C1-D01EBEA8AB74}"/>
                </a:ext>
              </a:extLst>
            </p:cNvPr>
            <p:cNvSpPr txBox="1"/>
            <p:nvPr/>
          </p:nvSpPr>
          <p:spPr>
            <a:xfrm>
              <a:off x="-1883429" y="4552336"/>
              <a:ext cx="273665" cy="25391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EAB7C642-CC8B-223D-6908-196C3F547506}"/>
                </a:ext>
              </a:extLst>
            </p:cNvPr>
            <p:cNvSpPr txBox="1"/>
            <p:nvPr/>
          </p:nvSpPr>
          <p:spPr>
            <a:xfrm>
              <a:off x="-1632465" y="4552336"/>
              <a:ext cx="32806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.1</a:t>
              </a: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552EC4BF-6BFB-1DBA-B8A8-1344C65FBC64}"/>
                </a:ext>
              </a:extLst>
            </p:cNvPr>
            <p:cNvSpPr txBox="1"/>
            <p:nvPr/>
          </p:nvSpPr>
          <p:spPr>
            <a:xfrm>
              <a:off x="-1778503" y="4552336"/>
              <a:ext cx="32125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.5</a:t>
              </a: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AB5BD979-1EF2-1F37-28A8-4162DE87BC8F}"/>
                </a:ext>
              </a:extLst>
            </p:cNvPr>
            <p:cNvSpPr txBox="1"/>
            <p:nvPr/>
          </p:nvSpPr>
          <p:spPr>
            <a:xfrm>
              <a:off x="-1465117" y="4552336"/>
              <a:ext cx="273665" cy="25391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A1F1C8E6-74BF-D4B1-8F07-8EDE999EDEFC}"/>
                </a:ext>
              </a:extLst>
            </p:cNvPr>
            <p:cNvSpPr txBox="1"/>
            <p:nvPr/>
          </p:nvSpPr>
          <p:spPr>
            <a:xfrm>
              <a:off x="-1322211" y="4552336"/>
              <a:ext cx="273665" cy="25391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3ADE0688-7E63-F296-E1E6-FB8459557A47}"/>
                </a:ext>
              </a:extLst>
            </p:cNvPr>
            <p:cNvSpPr txBox="1"/>
            <p:nvPr/>
          </p:nvSpPr>
          <p:spPr>
            <a:xfrm>
              <a:off x="-1165227" y="4552336"/>
              <a:ext cx="273665" cy="25391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A3779789-7A16-0DFC-7EE2-A52C694083F6}"/>
                </a:ext>
              </a:extLst>
            </p:cNvPr>
            <p:cNvSpPr txBox="1"/>
            <p:nvPr/>
          </p:nvSpPr>
          <p:spPr>
            <a:xfrm>
              <a:off x="-914262" y="4552336"/>
              <a:ext cx="31812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.1</a:t>
              </a: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E6DFB620-55B8-6D66-602C-372F05ED6A89}"/>
                </a:ext>
              </a:extLst>
            </p:cNvPr>
            <p:cNvSpPr txBox="1"/>
            <p:nvPr/>
          </p:nvSpPr>
          <p:spPr>
            <a:xfrm>
              <a:off x="-1060302" y="4552336"/>
              <a:ext cx="30795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.5</a:t>
              </a:r>
            </a:p>
          </p:txBody>
        </p:sp>
      </p:grpSp>
      <p:sp>
        <p:nvSpPr>
          <p:cNvPr id="24" name="TextBox 23">
            <a:extLst>
              <a:ext uri="{FF2B5EF4-FFF2-40B4-BE49-F238E27FC236}">
                <a16:creationId xmlns:a16="http://schemas.microsoft.com/office/drawing/2014/main" id="{122A0AF9-212B-C494-DB6D-5F511C956F52}"/>
              </a:ext>
            </a:extLst>
          </p:cNvPr>
          <p:cNvSpPr txBox="1"/>
          <p:nvPr/>
        </p:nvSpPr>
        <p:spPr>
          <a:xfrm>
            <a:off x="115850" y="1560806"/>
            <a:ext cx="283265" cy="1734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48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C2D0462C-BB15-A6AF-A563-7908248B5A94}"/>
              </a:ext>
            </a:extLst>
          </p:cNvPr>
          <p:cNvSpPr txBox="1"/>
          <p:nvPr/>
        </p:nvSpPr>
        <p:spPr>
          <a:xfrm>
            <a:off x="164025" y="2124060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796887FE-AA53-B4FC-8060-B39332904B12}"/>
              </a:ext>
            </a:extLst>
          </p:cNvPr>
          <p:cNvSpPr txBox="1"/>
          <p:nvPr/>
        </p:nvSpPr>
        <p:spPr>
          <a:xfrm>
            <a:off x="164025" y="2382798"/>
            <a:ext cx="235091" cy="1734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cxnSp>
        <p:nvCxnSpPr>
          <p:cNvPr id="27" name="Straight Connector 26">
            <a:extLst>
              <a:ext uri="{FF2B5EF4-FFF2-40B4-BE49-F238E27FC236}">
                <a16:creationId xmlns:a16="http://schemas.microsoft.com/office/drawing/2014/main" id="{5AD53C69-55C2-62AB-654E-032B3511C645}"/>
              </a:ext>
            </a:extLst>
          </p:cNvPr>
          <p:cNvCxnSpPr/>
          <p:nvPr/>
        </p:nvCxnSpPr>
        <p:spPr>
          <a:xfrm>
            <a:off x="417305" y="1678434"/>
            <a:ext cx="571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8" name="Straight Connector 27">
            <a:extLst>
              <a:ext uri="{FF2B5EF4-FFF2-40B4-BE49-F238E27FC236}">
                <a16:creationId xmlns:a16="http://schemas.microsoft.com/office/drawing/2014/main" id="{88FDED45-9D0D-3871-78B7-2BF6D17C9B14}"/>
              </a:ext>
            </a:extLst>
          </p:cNvPr>
          <p:cNvCxnSpPr/>
          <p:nvPr/>
        </p:nvCxnSpPr>
        <p:spPr>
          <a:xfrm>
            <a:off x="417305" y="2235427"/>
            <a:ext cx="571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9" name="Straight Connector 28">
            <a:extLst>
              <a:ext uri="{FF2B5EF4-FFF2-40B4-BE49-F238E27FC236}">
                <a16:creationId xmlns:a16="http://schemas.microsoft.com/office/drawing/2014/main" id="{A27F0A87-7CB4-E16D-6846-AA1002ECC84A}"/>
              </a:ext>
            </a:extLst>
          </p:cNvPr>
          <p:cNvCxnSpPr/>
          <p:nvPr/>
        </p:nvCxnSpPr>
        <p:spPr>
          <a:xfrm>
            <a:off x="421783" y="2495127"/>
            <a:ext cx="571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0" name="TextBox 39">
            <a:extLst>
              <a:ext uri="{FF2B5EF4-FFF2-40B4-BE49-F238E27FC236}">
                <a16:creationId xmlns:a16="http://schemas.microsoft.com/office/drawing/2014/main" id="{F1C74C64-CE4A-0C2F-9CDD-1AB0F7C13D04}"/>
              </a:ext>
            </a:extLst>
          </p:cNvPr>
          <p:cNvSpPr txBox="1"/>
          <p:nvPr/>
        </p:nvSpPr>
        <p:spPr>
          <a:xfrm>
            <a:off x="126949" y="695318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pic>
        <p:nvPicPr>
          <p:cNvPr id="41" name="Picture 40">
            <a:extLst>
              <a:ext uri="{FF2B5EF4-FFF2-40B4-BE49-F238E27FC236}">
                <a16:creationId xmlns:a16="http://schemas.microsoft.com/office/drawing/2014/main" id="{ED45B897-781D-3582-753C-EC64D98B7DA3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2" t="59" r="1266" b="200"/>
          <a:stretch/>
        </p:blipFill>
        <p:spPr>
          <a:xfrm rot="16200000">
            <a:off x="4208690" y="-218663"/>
            <a:ext cx="2247425" cy="355394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2" name="Picture 41">
            <a:extLst>
              <a:ext uri="{FF2B5EF4-FFF2-40B4-BE49-F238E27FC236}">
                <a16:creationId xmlns:a16="http://schemas.microsoft.com/office/drawing/2014/main" id="{F7E807B1-157E-0284-A8CA-BA2DCE3021E8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57" t="341" r="790" b="-68"/>
          <a:stretch/>
        </p:blipFill>
        <p:spPr>
          <a:xfrm rot="16200000">
            <a:off x="7431988" y="392176"/>
            <a:ext cx="3408777" cy="349361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3" name="Picture 42">
            <a:extLst>
              <a:ext uri="{FF2B5EF4-FFF2-40B4-BE49-F238E27FC236}">
                <a16:creationId xmlns:a16="http://schemas.microsoft.com/office/drawing/2014/main" id="{7A6B5316-2C6E-CA87-9C97-2503DC2CB323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288" t="151" r="388" b="834"/>
          <a:stretch/>
        </p:blipFill>
        <p:spPr>
          <a:xfrm rot="16200000">
            <a:off x="4081723" y="2497215"/>
            <a:ext cx="2501357" cy="3441033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4" name="Rectangle 43">
            <a:extLst>
              <a:ext uri="{FF2B5EF4-FFF2-40B4-BE49-F238E27FC236}">
                <a16:creationId xmlns:a16="http://schemas.microsoft.com/office/drawing/2014/main" id="{4FD364E7-D9D5-1C24-9DBF-07240B3CD883}"/>
              </a:ext>
            </a:extLst>
          </p:cNvPr>
          <p:cNvSpPr/>
          <p:nvPr/>
        </p:nvSpPr>
        <p:spPr>
          <a:xfrm>
            <a:off x="4314826" y="833817"/>
            <a:ext cx="981624" cy="32938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5" name="Rectangle 44">
            <a:extLst>
              <a:ext uri="{FF2B5EF4-FFF2-40B4-BE49-F238E27FC236}">
                <a16:creationId xmlns:a16="http://schemas.microsoft.com/office/drawing/2014/main" id="{3832CB52-EA1F-67A0-7D63-AA7044FB2F51}"/>
              </a:ext>
            </a:extLst>
          </p:cNvPr>
          <p:cNvSpPr/>
          <p:nvPr/>
        </p:nvSpPr>
        <p:spPr>
          <a:xfrm>
            <a:off x="7602675" y="1482825"/>
            <a:ext cx="981624" cy="32938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6" name="Rectangle 45">
            <a:extLst>
              <a:ext uri="{FF2B5EF4-FFF2-40B4-BE49-F238E27FC236}">
                <a16:creationId xmlns:a16="http://schemas.microsoft.com/office/drawing/2014/main" id="{35D14B37-3AF2-2843-9527-B650A15D7B94}"/>
              </a:ext>
            </a:extLst>
          </p:cNvPr>
          <p:cNvSpPr/>
          <p:nvPr/>
        </p:nvSpPr>
        <p:spPr>
          <a:xfrm>
            <a:off x="3931910" y="3678678"/>
            <a:ext cx="981624" cy="329387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2459E24A-81F8-633A-5B83-DBD8CE4B1122}"/>
              </a:ext>
            </a:extLst>
          </p:cNvPr>
          <p:cNvSpPr txBox="1"/>
          <p:nvPr/>
        </p:nvSpPr>
        <p:spPr>
          <a:xfrm>
            <a:off x="5306594" y="845359"/>
            <a:ext cx="655849" cy="2539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SP43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E47F302D-4ED8-13EC-B1C0-4A47C842EA22}"/>
              </a:ext>
            </a:extLst>
          </p:cNvPr>
          <p:cNvSpPr txBox="1"/>
          <p:nvPr/>
        </p:nvSpPr>
        <p:spPr>
          <a:xfrm>
            <a:off x="8548041" y="1551476"/>
            <a:ext cx="528526" cy="2539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CA9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9CBAC6B6-4E58-07A7-CF66-EA6C22794361}"/>
              </a:ext>
            </a:extLst>
          </p:cNvPr>
          <p:cNvSpPr txBox="1"/>
          <p:nvPr/>
        </p:nvSpPr>
        <p:spPr>
          <a:xfrm>
            <a:off x="4893791" y="3678678"/>
            <a:ext cx="599876" cy="2539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</a:p>
        </p:txBody>
      </p:sp>
    </p:spTree>
    <p:extLst>
      <p:ext uri="{BB962C8B-B14F-4D97-AF65-F5344CB8AC3E}">
        <p14:creationId xmlns:p14="http://schemas.microsoft.com/office/powerpoint/2010/main" val="216057557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DBF61E16-F1A2-83CA-96D1-99D998AF2EE0}"/>
              </a:ext>
            </a:extLst>
          </p:cNvPr>
          <p:cNvSpPr txBox="1"/>
          <p:nvPr/>
        </p:nvSpPr>
        <p:spPr>
          <a:xfrm>
            <a:off x="308432" y="248105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F2A2709B-D6DF-2F5E-D890-FD8A76FA8D5F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6681" t="62657" r="37322" b="17449"/>
          <a:stretch/>
        </p:blipFill>
        <p:spPr>
          <a:xfrm rot="5400000">
            <a:off x="1166717" y="654442"/>
            <a:ext cx="318347" cy="122578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A1D98F51-F9E0-85A8-25D0-01D137D1DB54}"/>
              </a:ext>
            </a:extLst>
          </p:cNvPr>
          <p:cNvSpPr txBox="1"/>
          <p:nvPr/>
        </p:nvSpPr>
        <p:spPr>
          <a:xfrm>
            <a:off x="615144" y="2503760"/>
            <a:ext cx="72327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eLa cells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15569389-A909-5894-8535-1BE05A8B2700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5683" t="26718" r="26548" b="52979"/>
          <a:stretch/>
        </p:blipFill>
        <p:spPr>
          <a:xfrm rot="5400000">
            <a:off x="1166717" y="1377868"/>
            <a:ext cx="318347" cy="122578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8B6BA3B0-BC6A-FC9C-4928-4850EBB23FE4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9230" t="73083" r="30304" b="20781"/>
          <a:stretch/>
        </p:blipFill>
        <p:spPr>
          <a:xfrm>
            <a:off x="712998" y="2193301"/>
            <a:ext cx="1225785" cy="31834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064D5E29-17C1-137D-37C9-FCD4F7040DB7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322" t="22377" r="77510" b="55665"/>
          <a:stretch/>
        </p:blipFill>
        <p:spPr>
          <a:xfrm rot="5400000">
            <a:off x="1166717" y="1016155"/>
            <a:ext cx="318347" cy="122578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22CBC17E-D1A9-787D-4F65-DDAA7E168317}"/>
              </a:ext>
            </a:extLst>
          </p:cNvPr>
          <p:cNvSpPr txBox="1"/>
          <p:nvPr/>
        </p:nvSpPr>
        <p:spPr>
          <a:xfrm>
            <a:off x="774644" y="405134"/>
            <a:ext cx="506336" cy="1907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21 % O</a:t>
            </a:r>
            <a:r>
              <a:rPr lang="en-GB" sz="9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" name="Straight Connector 9">
            <a:extLst>
              <a:ext uri="{FF2B5EF4-FFF2-40B4-BE49-F238E27FC236}">
                <a16:creationId xmlns:a16="http://schemas.microsoft.com/office/drawing/2014/main" id="{D9FDCB10-1726-361C-2825-B2D0EAA5F3D1}"/>
              </a:ext>
            </a:extLst>
          </p:cNvPr>
          <p:cNvCxnSpPr>
            <a:cxnSpLocks/>
          </p:cNvCxnSpPr>
          <p:nvPr/>
        </p:nvCxnSpPr>
        <p:spPr>
          <a:xfrm flipV="1">
            <a:off x="724584" y="624785"/>
            <a:ext cx="588249" cy="219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>
            <a:extLst>
              <a:ext uri="{FF2B5EF4-FFF2-40B4-BE49-F238E27FC236}">
                <a16:creationId xmlns:a16="http://schemas.microsoft.com/office/drawing/2014/main" id="{BE9C0D9B-4AD5-1BEF-3264-8A1EC59B9605}"/>
              </a:ext>
            </a:extLst>
          </p:cNvPr>
          <p:cNvSpPr txBox="1"/>
          <p:nvPr/>
        </p:nvSpPr>
        <p:spPr>
          <a:xfrm>
            <a:off x="1337282" y="405133"/>
            <a:ext cx="70987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 % O</a:t>
            </a:r>
            <a:r>
              <a:rPr lang="en-GB" sz="9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09AD4CBB-D4DE-78A7-A8A2-70AFF4C744B1}"/>
              </a:ext>
            </a:extLst>
          </p:cNvPr>
          <p:cNvSpPr txBox="1"/>
          <p:nvPr/>
        </p:nvSpPr>
        <p:spPr>
          <a:xfrm>
            <a:off x="2071042" y="757139"/>
            <a:ext cx="751423" cy="1907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SP43 siRNA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F15A52B6-9BF9-50ED-0E91-30C7DB3962B4}"/>
              </a:ext>
            </a:extLst>
          </p:cNvPr>
          <p:cNvSpPr txBox="1"/>
          <p:nvPr/>
        </p:nvSpPr>
        <p:spPr>
          <a:xfrm>
            <a:off x="2061517" y="903260"/>
            <a:ext cx="618944" cy="1907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A-USP43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7ADE7316-294C-7C7E-B8B1-438D333B9728}"/>
              </a:ext>
            </a:extLst>
          </p:cNvPr>
          <p:cNvSpPr txBox="1"/>
          <p:nvPr/>
        </p:nvSpPr>
        <p:spPr>
          <a:xfrm>
            <a:off x="723311" y="915868"/>
            <a:ext cx="184412" cy="1907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02535307-1F61-8926-CC89-AC07F03D350A}"/>
              </a:ext>
            </a:extLst>
          </p:cNvPr>
          <p:cNvSpPr txBox="1"/>
          <p:nvPr/>
        </p:nvSpPr>
        <p:spPr>
          <a:xfrm>
            <a:off x="1152062" y="778073"/>
            <a:ext cx="139592" cy="1907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2FD265F1-61A2-2A29-2331-82C447015EF8}"/>
              </a:ext>
            </a:extLst>
          </p:cNvPr>
          <p:cNvSpPr txBox="1"/>
          <p:nvPr/>
        </p:nvSpPr>
        <p:spPr>
          <a:xfrm>
            <a:off x="723311" y="778073"/>
            <a:ext cx="184412" cy="1907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9F71D2DC-B2B2-0A1A-C168-A9A69B01773B}"/>
              </a:ext>
            </a:extLst>
          </p:cNvPr>
          <p:cNvSpPr txBox="1"/>
          <p:nvPr/>
        </p:nvSpPr>
        <p:spPr>
          <a:xfrm>
            <a:off x="922412" y="778073"/>
            <a:ext cx="208258" cy="1907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E8ABB485-0B35-436E-A91E-368340848A2F}"/>
              </a:ext>
            </a:extLst>
          </p:cNvPr>
          <p:cNvSpPr txBox="1"/>
          <p:nvPr/>
        </p:nvSpPr>
        <p:spPr>
          <a:xfrm>
            <a:off x="1152062" y="915868"/>
            <a:ext cx="139592" cy="1907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23AA589B-ACED-3D3E-AE57-FA0CFF5B1FA1}"/>
              </a:ext>
            </a:extLst>
          </p:cNvPr>
          <p:cNvSpPr txBox="1"/>
          <p:nvPr/>
        </p:nvSpPr>
        <p:spPr>
          <a:xfrm>
            <a:off x="937687" y="915868"/>
            <a:ext cx="184412" cy="1907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id="{9AC8B522-DCE5-4FA0-A173-A6EEE1D44FE2}"/>
              </a:ext>
            </a:extLst>
          </p:cNvPr>
          <p:cNvCxnSpPr>
            <a:cxnSpLocks/>
          </p:cNvCxnSpPr>
          <p:nvPr/>
        </p:nvCxnSpPr>
        <p:spPr>
          <a:xfrm flipV="1">
            <a:off x="1350413" y="621389"/>
            <a:ext cx="588249" cy="219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20">
            <a:extLst>
              <a:ext uri="{FF2B5EF4-FFF2-40B4-BE49-F238E27FC236}">
                <a16:creationId xmlns:a16="http://schemas.microsoft.com/office/drawing/2014/main" id="{A4DDFEF3-B321-CFEA-1CC3-26F30FBE88C4}"/>
              </a:ext>
            </a:extLst>
          </p:cNvPr>
          <p:cNvSpPr txBox="1"/>
          <p:nvPr/>
        </p:nvSpPr>
        <p:spPr>
          <a:xfrm>
            <a:off x="1349139" y="918955"/>
            <a:ext cx="184412" cy="1907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D669C949-C5EE-7C52-5E49-5AAE453F9D54}"/>
              </a:ext>
            </a:extLst>
          </p:cNvPr>
          <p:cNvSpPr txBox="1"/>
          <p:nvPr/>
        </p:nvSpPr>
        <p:spPr>
          <a:xfrm>
            <a:off x="1777891" y="781160"/>
            <a:ext cx="139592" cy="1907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F9F9946F-CC89-8B0A-0107-729D711516DC}"/>
              </a:ext>
            </a:extLst>
          </p:cNvPr>
          <p:cNvSpPr txBox="1"/>
          <p:nvPr/>
        </p:nvSpPr>
        <p:spPr>
          <a:xfrm>
            <a:off x="1349139" y="781160"/>
            <a:ext cx="184412" cy="1907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120E056E-857D-F244-E165-3A6DBDEB9FBF}"/>
              </a:ext>
            </a:extLst>
          </p:cNvPr>
          <p:cNvSpPr txBox="1"/>
          <p:nvPr/>
        </p:nvSpPr>
        <p:spPr>
          <a:xfrm>
            <a:off x="1548239" y="781160"/>
            <a:ext cx="208258" cy="1907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B8BD742F-9D1B-F7EA-EF13-C4E8F1EC8247}"/>
              </a:ext>
            </a:extLst>
          </p:cNvPr>
          <p:cNvSpPr txBox="1"/>
          <p:nvPr/>
        </p:nvSpPr>
        <p:spPr>
          <a:xfrm>
            <a:off x="1777891" y="918955"/>
            <a:ext cx="139592" cy="1907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36BD303B-1FE3-6922-B02D-280DA051BE71}"/>
              </a:ext>
            </a:extLst>
          </p:cNvPr>
          <p:cNvSpPr txBox="1"/>
          <p:nvPr/>
        </p:nvSpPr>
        <p:spPr>
          <a:xfrm>
            <a:off x="1563516" y="918955"/>
            <a:ext cx="184412" cy="1907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23A0F9D4-72C2-2B39-5F09-7F7379BC5060}"/>
              </a:ext>
            </a:extLst>
          </p:cNvPr>
          <p:cNvSpPr txBox="1"/>
          <p:nvPr/>
        </p:nvSpPr>
        <p:spPr>
          <a:xfrm>
            <a:off x="1943288" y="1155936"/>
            <a:ext cx="667106" cy="1907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SP43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748D65D1-CA23-A2ED-94E6-EB8E56F20184}"/>
              </a:ext>
            </a:extLst>
          </p:cNvPr>
          <p:cNvSpPr txBox="1"/>
          <p:nvPr/>
        </p:nvSpPr>
        <p:spPr>
          <a:xfrm>
            <a:off x="1949952" y="1868884"/>
            <a:ext cx="537597" cy="1907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CA9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06EE1F63-B4A1-B58A-1C2B-6C919AF44552}"/>
              </a:ext>
            </a:extLst>
          </p:cNvPr>
          <p:cNvSpPr txBox="1"/>
          <p:nvPr/>
        </p:nvSpPr>
        <p:spPr>
          <a:xfrm>
            <a:off x="1949952" y="2211691"/>
            <a:ext cx="450696" cy="1907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29E2B61F-937D-B553-7A44-03E24B63C8B6}"/>
              </a:ext>
            </a:extLst>
          </p:cNvPr>
          <p:cNvSpPr txBox="1"/>
          <p:nvPr/>
        </p:nvSpPr>
        <p:spPr>
          <a:xfrm>
            <a:off x="1949952" y="1536450"/>
            <a:ext cx="446721" cy="1907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-1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9CE7E9D9-E806-7F89-4F03-E2DC1C826274}"/>
              </a:ext>
            </a:extLst>
          </p:cNvPr>
          <p:cNvSpPr txBox="1"/>
          <p:nvPr/>
        </p:nvSpPr>
        <p:spPr>
          <a:xfrm>
            <a:off x="2061517" y="619501"/>
            <a:ext cx="677235" cy="1907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Mock siRNA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521EF1CF-0B93-3EE9-9C18-DCB451E60A7E}"/>
              </a:ext>
            </a:extLst>
          </p:cNvPr>
          <p:cNvSpPr txBox="1"/>
          <p:nvPr/>
        </p:nvSpPr>
        <p:spPr>
          <a:xfrm>
            <a:off x="924131" y="615355"/>
            <a:ext cx="184412" cy="1907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512E3E98-5212-EA52-EE6E-088C6189F655}"/>
              </a:ext>
            </a:extLst>
          </p:cNvPr>
          <p:cNvSpPr txBox="1"/>
          <p:nvPr/>
        </p:nvSpPr>
        <p:spPr>
          <a:xfrm>
            <a:off x="1328708" y="615355"/>
            <a:ext cx="139592" cy="1907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A54E63EB-F28D-C7B4-43E3-5ED2D98BC85A}"/>
              </a:ext>
            </a:extLst>
          </p:cNvPr>
          <p:cNvSpPr txBox="1"/>
          <p:nvPr/>
        </p:nvSpPr>
        <p:spPr>
          <a:xfrm>
            <a:off x="1138508" y="615355"/>
            <a:ext cx="184412" cy="1907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B1DEBE1A-8A8F-B99D-06EB-FB7B70D205DE}"/>
              </a:ext>
            </a:extLst>
          </p:cNvPr>
          <p:cNvSpPr txBox="1"/>
          <p:nvPr/>
        </p:nvSpPr>
        <p:spPr>
          <a:xfrm>
            <a:off x="711497" y="615355"/>
            <a:ext cx="139592" cy="1907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88C7EE92-5DB4-C91D-A866-F83E71E9D4DB}"/>
              </a:ext>
            </a:extLst>
          </p:cNvPr>
          <p:cNvSpPr txBox="1"/>
          <p:nvPr/>
        </p:nvSpPr>
        <p:spPr>
          <a:xfrm>
            <a:off x="1563367" y="615355"/>
            <a:ext cx="184412" cy="1907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045BA48A-6447-325B-F640-8CD1F8B6E6D8}"/>
              </a:ext>
            </a:extLst>
          </p:cNvPr>
          <p:cNvSpPr txBox="1"/>
          <p:nvPr/>
        </p:nvSpPr>
        <p:spPr>
          <a:xfrm>
            <a:off x="1777742" y="615355"/>
            <a:ext cx="184412" cy="1907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6CAE374B-129E-7A3C-E981-FBD64A392930}"/>
              </a:ext>
            </a:extLst>
          </p:cNvPr>
          <p:cNvSpPr txBox="1"/>
          <p:nvPr/>
        </p:nvSpPr>
        <p:spPr>
          <a:xfrm>
            <a:off x="332495" y="873334"/>
            <a:ext cx="322190" cy="1907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F62FC831-2234-759F-4951-84A5F22CCEA8}"/>
              </a:ext>
            </a:extLst>
          </p:cNvPr>
          <p:cNvSpPr txBox="1"/>
          <p:nvPr/>
        </p:nvSpPr>
        <p:spPr>
          <a:xfrm>
            <a:off x="320177" y="1066768"/>
            <a:ext cx="283265" cy="1734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48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23F81B5C-45E2-CFB5-BF73-F12AC333199B}"/>
              </a:ext>
            </a:extLst>
          </p:cNvPr>
          <p:cNvSpPr txBox="1"/>
          <p:nvPr/>
        </p:nvSpPr>
        <p:spPr>
          <a:xfrm>
            <a:off x="368352" y="1531302"/>
            <a:ext cx="235091" cy="1734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98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C2C0F113-860F-EC33-59D8-42B505D2DE00}"/>
              </a:ext>
            </a:extLst>
          </p:cNvPr>
          <p:cNvSpPr txBox="1"/>
          <p:nvPr/>
        </p:nvSpPr>
        <p:spPr>
          <a:xfrm>
            <a:off x="368352" y="1931867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36C517D9-8DD1-3B7D-B041-7ED4D7A2D524}"/>
              </a:ext>
            </a:extLst>
          </p:cNvPr>
          <p:cNvSpPr txBox="1"/>
          <p:nvPr/>
        </p:nvSpPr>
        <p:spPr>
          <a:xfrm>
            <a:off x="368352" y="2270504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cxnSp>
        <p:nvCxnSpPr>
          <p:cNvPr id="43" name="Straight Connector 42">
            <a:extLst>
              <a:ext uri="{FF2B5EF4-FFF2-40B4-BE49-F238E27FC236}">
                <a16:creationId xmlns:a16="http://schemas.microsoft.com/office/drawing/2014/main" id="{C4ADD160-BE7C-4010-DCB2-CC864DE1B890}"/>
              </a:ext>
            </a:extLst>
          </p:cNvPr>
          <p:cNvCxnSpPr/>
          <p:nvPr/>
        </p:nvCxnSpPr>
        <p:spPr>
          <a:xfrm>
            <a:off x="621632" y="1184396"/>
            <a:ext cx="571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4" name="Straight Connector 43">
            <a:extLst>
              <a:ext uri="{FF2B5EF4-FFF2-40B4-BE49-F238E27FC236}">
                <a16:creationId xmlns:a16="http://schemas.microsoft.com/office/drawing/2014/main" id="{1E1388E7-37A2-646F-9C89-034B8759503B}"/>
              </a:ext>
            </a:extLst>
          </p:cNvPr>
          <p:cNvCxnSpPr/>
          <p:nvPr/>
        </p:nvCxnSpPr>
        <p:spPr>
          <a:xfrm>
            <a:off x="621632" y="1641624"/>
            <a:ext cx="571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5" name="Straight Connector 44">
            <a:extLst>
              <a:ext uri="{FF2B5EF4-FFF2-40B4-BE49-F238E27FC236}">
                <a16:creationId xmlns:a16="http://schemas.microsoft.com/office/drawing/2014/main" id="{3FA49AC5-26D1-80BA-B8AD-2227EAB51139}"/>
              </a:ext>
            </a:extLst>
          </p:cNvPr>
          <p:cNvCxnSpPr/>
          <p:nvPr/>
        </p:nvCxnSpPr>
        <p:spPr>
          <a:xfrm>
            <a:off x="621632" y="2043234"/>
            <a:ext cx="571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6" name="Straight Connector 45">
            <a:extLst>
              <a:ext uri="{FF2B5EF4-FFF2-40B4-BE49-F238E27FC236}">
                <a16:creationId xmlns:a16="http://schemas.microsoft.com/office/drawing/2014/main" id="{AC6CC9E5-DB12-154C-7091-787E21807815}"/>
              </a:ext>
            </a:extLst>
          </p:cNvPr>
          <p:cNvCxnSpPr/>
          <p:nvPr/>
        </p:nvCxnSpPr>
        <p:spPr>
          <a:xfrm>
            <a:off x="626110" y="2382833"/>
            <a:ext cx="571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92" name="Picture 91">
            <a:extLst>
              <a:ext uri="{FF2B5EF4-FFF2-40B4-BE49-F238E27FC236}">
                <a16:creationId xmlns:a16="http://schemas.microsoft.com/office/drawing/2014/main" id="{617ACEA5-469B-9BCB-E288-B4843748EC43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59" t="-175" r="494" b="-152"/>
          <a:stretch/>
        </p:blipFill>
        <p:spPr>
          <a:xfrm rot="5400000">
            <a:off x="3340467" y="-12660"/>
            <a:ext cx="2967893" cy="348942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3" name="Picture 92">
            <a:extLst>
              <a:ext uri="{FF2B5EF4-FFF2-40B4-BE49-F238E27FC236}">
                <a16:creationId xmlns:a16="http://schemas.microsoft.com/office/drawing/2014/main" id="{A6DE2193-2592-CCFA-3D33-B47BD1FBBB97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21" t="289" r="-105" b="577"/>
          <a:stretch/>
        </p:blipFill>
        <p:spPr>
          <a:xfrm rot="5400000">
            <a:off x="7326607" y="-241111"/>
            <a:ext cx="2124075" cy="312381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4" name="Picture 93">
            <a:extLst>
              <a:ext uri="{FF2B5EF4-FFF2-40B4-BE49-F238E27FC236}">
                <a16:creationId xmlns:a16="http://schemas.microsoft.com/office/drawing/2014/main" id="{37A961CA-B261-93A9-5F54-D3ACC237650E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27" t="412" r="-951" b="783"/>
          <a:stretch/>
        </p:blipFill>
        <p:spPr>
          <a:xfrm rot="5400000">
            <a:off x="3607728" y="2900974"/>
            <a:ext cx="2311274" cy="336732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5" name="Picture 94">
            <a:extLst>
              <a:ext uri="{FF2B5EF4-FFF2-40B4-BE49-F238E27FC236}">
                <a16:creationId xmlns:a16="http://schemas.microsoft.com/office/drawing/2014/main" id="{B16F2010-6D7C-52F6-C715-01101AAB5FF1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1" t="886" r="175" b="-576"/>
          <a:stretch/>
        </p:blipFill>
        <p:spPr>
          <a:xfrm>
            <a:off x="6921050" y="2820774"/>
            <a:ext cx="3365760" cy="2919501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96" name="Rectangle 95">
            <a:extLst>
              <a:ext uri="{FF2B5EF4-FFF2-40B4-BE49-F238E27FC236}">
                <a16:creationId xmlns:a16="http://schemas.microsoft.com/office/drawing/2014/main" id="{E1278C97-869F-3CEC-3B0B-927207B3F58A}"/>
              </a:ext>
            </a:extLst>
          </p:cNvPr>
          <p:cNvSpPr/>
          <p:nvPr/>
        </p:nvSpPr>
        <p:spPr>
          <a:xfrm>
            <a:off x="3628467" y="1907123"/>
            <a:ext cx="811259" cy="27222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7" name="Rectangle 96">
            <a:extLst>
              <a:ext uri="{FF2B5EF4-FFF2-40B4-BE49-F238E27FC236}">
                <a16:creationId xmlns:a16="http://schemas.microsoft.com/office/drawing/2014/main" id="{36E0B26D-89DE-83A5-C290-133333BFF6D5}"/>
              </a:ext>
            </a:extLst>
          </p:cNvPr>
          <p:cNvSpPr/>
          <p:nvPr/>
        </p:nvSpPr>
        <p:spPr>
          <a:xfrm>
            <a:off x="8457642" y="459793"/>
            <a:ext cx="811259" cy="27222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8" name="Rectangle 97">
            <a:extLst>
              <a:ext uri="{FF2B5EF4-FFF2-40B4-BE49-F238E27FC236}">
                <a16:creationId xmlns:a16="http://schemas.microsoft.com/office/drawing/2014/main" id="{0EA3A445-9410-AD8D-3AD5-C0FF5F20CAA2}"/>
              </a:ext>
            </a:extLst>
          </p:cNvPr>
          <p:cNvSpPr/>
          <p:nvPr/>
        </p:nvSpPr>
        <p:spPr>
          <a:xfrm>
            <a:off x="4763365" y="4907968"/>
            <a:ext cx="811259" cy="27222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9" name="Rectangle 98">
            <a:extLst>
              <a:ext uri="{FF2B5EF4-FFF2-40B4-BE49-F238E27FC236}">
                <a16:creationId xmlns:a16="http://schemas.microsoft.com/office/drawing/2014/main" id="{8E9EB27D-7902-D800-2DE2-B5650978D523}"/>
              </a:ext>
            </a:extLst>
          </p:cNvPr>
          <p:cNvSpPr/>
          <p:nvPr/>
        </p:nvSpPr>
        <p:spPr>
          <a:xfrm>
            <a:off x="8580995" y="4913241"/>
            <a:ext cx="670462" cy="20452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00" name="TextBox 99">
            <a:extLst>
              <a:ext uri="{FF2B5EF4-FFF2-40B4-BE49-F238E27FC236}">
                <a16:creationId xmlns:a16="http://schemas.microsoft.com/office/drawing/2014/main" id="{FDA9ABAA-C8F6-CD1F-C268-AC92FE74A984}"/>
              </a:ext>
            </a:extLst>
          </p:cNvPr>
          <p:cNvSpPr txBox="1"/>
          <p:nvPr/>
        </p:nvSpPr>
        <p:spPr>
          <a:xfrm>
            <a:off x="4439726" y="1931132"/>
            <a:ext cx="667106" cy="1907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SP43</a:t>
            </a:r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id="{F702A7BF-6C66-652B-9F85-78ED158BBDED}"/>
              </a:ext>
            </a:extLst>
          </p:cNvPr>
          <p:cNvSpPr txBox="1"/>
          <p:nvPr/>
        </p:nvSpPr>
        <p:spPr>
          <a:xfrm>
            <a:off x="9258050" y="500518"/>
            <a:ext cx="446721" cy="1907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-1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id="{ACF75E25-9C49-A35E-C993-4BA5EB42F363}"/>
              </a:ext>
            </a:extLst>
          </p:cNvPr>
          <p:cNvSpPr txBox="1"/>
          <p:nvPr/>
        </p:nvSpPr>
        <p:spPr>
          <a:xfrm>
            <a:off x="5558403" y="4907968"/>
            <a:ext cx="537597" cy="1907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CA9</a:t>
            </a:r>
          </a:p>
        </p:txBody>
      </p:sp>
      <p:sp>
        <p:nvSpPr>
          <p:cNvPr id="103" name="TextBox 102">
            <a:extLst>
              <a:ext uri="{FF2B5EF4-FFF2-40B4-BE49-F238E27FC236}">
                <a16:creationId xmlns:a16="http://schemas.microsoft.com/office/drawing/2014/main" id="{36FE7EC3-5615-8B09-506B-2BDC26212827}"/>
              </a:ext>
            </a:extLst>
          </p:cNvPr>
          <p:cNvSpPr txBox="1"/>
          <p:nvPr/>
        </p:nvSpPr>
        <p:spPr>
          <a:xfrm>
            <a:off x="8794493" y="5181232"/>
            <a:ext cx="450696" cy="1907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</a:p>
        </p:txBody>
      </p:sp>
    </p:spTree>
    <p:extLst>
      <p:ext uri="{BB962C8B-B14F-4D97-AF65-F5344CB8AC3E}">
        <p14:creationId xmlns:p14="http://schemas.microsoft.com/office/powerpoint/2010/main" val="3413763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TextBox 46">
            <a:extLst>
              <a:ext uri="{FF2B5EF4-FFF2-40B4-BE49-F238E27FC236}">
                <a16:creationId xmlns:a16="http://schemas.microsoft.com/office/drawing/2014/main" id="{83AF477F-31DE-A4D7-E2A4-D4AC5B5D782D}"/>
              </a:ext>
            </a:extLst>
          </p:cNvPr>
          <p:cNvSpPr txBox="1"/>
          <p:nvPr/>
        </p:nvSpPr>
        <p:spPr>
          <a:xfrm>
            <a:off x="335212" y="76655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pic>
        <p:nvPicPr>
          <p:cNvPr id="49" name="Picture 48">
            <a:extLst>
              <a:ext uri="{FF2B5EF4-FFF2-40B4-BE49-F238E27FC236}">
                <a16:creationId xmlns:a16="http://schemas.microsoft.com/office/drawing/2014/main" id="{DE50BFEB-CD1A-9DDF-01DE-D85C458942CF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919" t="62850" r="74858" b="15984"/>
          <a:stretch/>
        </p:blipFill>
        <p:spPr>
          <a:xfrm rot="5400000">
            <a:off x="1199720" y="536279"/>
            <a:ext cx="316800" cy="12276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0" name="Picture 49">
            <a:extLst>
              <a:ext uri="{FF2B5EF4-FFF2-40B4-BE49-F238E27FC236}">
                <a16:creationId xmlns:a16="http://schemas.microsoft.com/office/drawing/2014/main" id="{9B44CB5B-A2B3-417D-CF35-081E2A67B6DD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864" t="22901" r="76913" b="55933"/>
          <a:stretch/>
        </p:blipFill>
        <p:spPr>
          <a:xfrm rot="5400000">
            <a:off x="1199720" y="1628154"/>
            <a:ext cx="316800" cy="12276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1" name="Picture 50">
            <a:extLst>
              <a:ext uri="{FF2B5EF4-FFF2-40B4-BE49-F238E27FC236}">
                <a16:creationId xmlns:a16="http://schemas.microsoft.com/office/drawing/2014/main" id="{32E91053-02E1-2707-CC31-DC95A38A4E2F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321" t="23778" r="83455" b="55786"/>
          <a:stretch/>
        </p:blipFill>
        <p:spPr>
          <a:xfrm rot="5400000">
            <a:off x="1199720" y="1266765"/>
            <a:ext cx="316800" cy="12276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2" name="Picture 51">
            <a:extLst>
              <a:ext uri="{FF2B5EF4-FFF2-40B4-BE49-F238E27FC236}">
                <a16:creationId xmlns:a16="http://schemas.microsoft.com/office/drawing/2014/main" id="{98144D3F-9C5D-66C1-2C53-91804977199C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229" t="64965" r="76106" b="14603"/>
          <a:stretch/>
        </p:blipFill>
        <p:spPr>
          <a:xfrm rot="5400000">
            <a:off x="1199720" y="905124"/>
            <a:ext cx="316800" cy="12276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3" name="TextBox 52">
            <a:extLst>
              <a:ext uri="{FF2B5EF4-FFF2-40B4-BE49-F238E27FC236}">
                <a16:creationId xmlns:a16="http://schemas.microsoft.com/office/drawing/2014/main" id="{291FD076-7B2A-2C68-D8FC-AAE9E6A5DD21}"/>
              </a:ext>
            </a:extLst>
          </p:cNvPr>
          <p:cNvSpPr txBox="1"/>
          <p:nvPr/>
        </p:nvSpPr>
        <p:spPr>
          <a:xfrm>
            <a:off x="653543" y="2412560"/>
            <a:ext cx="71686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A549 cells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5A53B8D4-F110-33B5-2117-5451AE6DCAD2}"/>
              </a:ext>
            </a:extLst>
          </p:cNvPr>
          <p:cNvSpPr txBox="1"/>
          <p:nvPr/>
        </p:nvSpPr>
        <p:spPr>
          <a:xfrm>
            <a:off x="775081" y="275933"/>
            <a:ext cx="506336" cy="1907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21 % O</a:t>
            </a:r>
            <a:r>
              <a:rPr lang="en-GB" sz="9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5" name="Straight Connector 54">
            <a:extLst>
              <a:ext uri="{FF2B5EF4-FFF2-40B4-BE49-F238E27FC236}">
                <a16:creationId xmlns:a16="http://schemas.microsoft.com/office/drawing/2014/main" id="{63E4C410-D999-47A7-B58E-F9FAADCC8F82}"/>
              </a:ext>
            </a:extLst>
          </p:cNvPr>
          <p:cNvCxnSpPr>
            <a:cxnSpLocks/>
          </p:cNvCxnSpPr>
          <p:nvPr/>
        </p:nvCxnSpPr>
        <p:spPr>
          <a:xfrm flipV="1">
            <a:off x="725021" y="495584"/>
            <a:ext cx="588249" cy="219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TextBox 55">
            <a:extLst>
              <a:ext uri="{FF2B5EF4-FFF2-40B4-BE49-F238E27FC236}">
                <a16:creationId xmlns:a16="http://schemas.microsoft.com/office/drawing/2014/main" id="{3695DE38-F848-6E8C-E3A7-D48612A6DA74}"/>
              </a:ext>
            </a:extLst>
          </p:cNvPr>
          <p:cNvSpPr txBox="1"/>
          <p:nvPr/>
        </p:nvSpPr>
        <p:spPr>
          <a:xfrm>
            <a:off x="1337719" y="275932"/>
            <a:ext cx="70987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 % O</a:t>
            </a:r>
            <a:r>
              <a:rPr lang="en-GB" sz="9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AB5533AA-2873-B37F-9798-9B90E4E9271F}"/>
              </a:ext>
            </a:extLst>
          </p:cNvPr>
          <p:cNvSpPr txBox="1"/>
          <p:nvPr/>
        </p:nvSpPr>
        <p:spPr>
          <a:xfrm>
            <a:off x="2071479" y="627938"/>
            <a:ext cx="751423" cy="1907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SP43 siRNA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708814BE-9643-28B5-DB8B-21FA09709ACA}"/>
              </a:ext>
            </a:extLst>
          </p:cNvPr>
          <p:cNvSpPr txBox="1"/>
          <p:nvPr/>
        </p:nvSpPr>
        <p:spPr>
          <a:xfrm>
            <a:off x="2061954" y="774059"/>
            <a:ext cx="618944" cy="1907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A-USP43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2E449E6C-626D-1E6E-E562-C854616DB1FA}"/>
              </a:ext>
            </a:extLst>
          </p:cNvPr>
          <p:cNvSpPr txBox="1"/>
          <p:nvPr/>
        </p:nvSpPr>
        <p:spPr>
          <a:xfrm>
            <a:off x="723748" y="786667"/>
            <a:ext cx="184412" cy="1907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53CC319B-0A66-85D5-8A54-DECD79696823}"/>
              </a:ext>
            </a:extLst>
          </p:cNvPr>
          <p:cNvSpPr txBox="1"/>
          <p:nvPr/>
        </p:nvSpPr>
        <p:spPr>
          <a:xfrm>
            <a:off x="1152499" y="648872"/>
            <a:ext cx="139592" cy="1907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82648D28-4748-BC02-B488-274372C2889C}"/>
              </a:ext>
            </a:extLst>
          </p:cNvPr>
          <p:cNvSpPr txBox="1"/>
          <p:nvPr/>
        </p:nvSpPr>
        <p:spPr>
          <a:xfrm>
            <a:off x="723748" y="648872"/>
            <a:ext cx="184412" cy="1907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7D5F9E29-FB43-23D0-88B5-468F4629D5B6}"/>
              </a:ext>
            </a:extLst>
          </p:cNvPr>
          <p:cNvSpPr txBox="1"/>
          <p:nvPr/>
        </p:nvSpPr>
        <p:spPr>
          <a:xfrm>
            <a:off x="922849" y="648872"/>
            <a:ext cx="208258" cy="1907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BDD1E589-1DFC-8C49-2303-67F182BFA443}"/>
              </a:ext>
            </a:extLst>
          </p:cNvPr>
          <p:cNvSpPr txBox="1"/>
          <p:nvPr/>
        </p:nvSpPr>
        <p:spPr>
          <a:xfrm>
            <a:off x="1152499" y="786667"/>
            <a:ext cx="139592" cy="1907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BA136EC5-96B9-4AB9-99F0-86489EE96270}"/>
              </a:ext>
            </a:extLst>
          </p:cNvPr>
          <p:cNvSpPr txBox="1"/>
          <p:nvPr/>
        </p:nvSpPr>
        <p:spPr>
          <a:xfrm>
            <a:off x="938124" y="786667"/>
            <a:ext cx="184412" cy="1907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cxnSp>
        <p:nvCxnSpPr>
          <p:cNvPr id="65" name="Straight Connector 64">
            <a:extLst>
              <a:ext uri="{FF2B5EF4-FFF2-40B4-BE49-F238E27FC236}">
                <a16:creationId xmlns:a16="http://schemas.microsoft.com/office/drawing/2014/main" id="{F043DEDD-1F53-D180-5DAE-89EE3105B32B}"/>
              </a:ext>
            </a:extLst>
          </p:cNvPr>
          <p:cNvCxnSpPr>
            <a:cxnSpLocks/>
          </p:cNvCxnSpPr>
          <p:nvPr/>
        </p:nvCxnSpPr>
        <p:spPr>
          <a:xfrm flipV="1">
            <a:off x="1350850" y="492188"/>
            <a:ext cx="588249" cy="219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6" name="TextBox 65">
            <a:extLst>
              <a:ext uri="{FF2B5EF4-FFF2-40B4-BE49-F238E27FC236}">
                <a16:creationId xmlns:a16="http://schemas.microsoft.com/office/drawing/2014/main" id="{12C01B56-A980-A18D-1BEF-82D997D7B708}"/>
              </a:ext>
            </a:extLst>
          </p:cNvPr>
          <p:cNvSpPr txBox="1"/>
          <p:nvPr/>
        </p:nvSpPr>
        <p:spPr>
          <a:xfrm>
            <a:off x="1349576" y="789754"/>
            <a:ext cx="184412" cy="1907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CA692653-506E-7787-604D-B5D53021E7FC}"/>
              </a:ext>
            </a:extLst>
          </p:cNvPr>
          <p:cNvSpPr txBox="1"/>
          <p:nvPr/>
        </p:nvSpPr>
        <p:spPr>
          <a:xfrm>
            <a:off x="1778328" y="651959"/>
            <a:ext cx="139592" cy="1907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696211D2-CAA3-E753-E467-3DB4AAAC6A25}"/>
              </a:ext>
            </a:extLst>
          </p:cNvPr>
          <p:cNvSpPr txBox="1"/>
          <p:nvPr/>
        </p:nvSpPr>
        <p:spPr>
          <a:xfrm>
            <a:off x="1349576" y="651959"/>
            <a:ext cx="184412" cy="1907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839F099F-7B9C-EDEF-6074-A3C9A23F9E1E}"/>
              </a:ext>
            </a:extLst>
          </p:cNvPr>
          <p:cNvSpPr txBox="1"/>
          <p:nvPr/>
        </p:nvSpPr>
        <p:spPr>
          <a:xfrm>
            <a:off x="1548676" y="651959"/>
            <a:ext cx="208258" cy="1907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4925ED4C-E37F-EA12-36BA-6BEF67E78DE2}"/>
              </a:ext>
            </a:extLst>
          </p:cNvPr>
          <p:cNvSpPr txBox="1"/>
          <p:nvPr/>
        </p:nvSpPr>
        <p:spPr>
          <a:xfrm>
            <a:off x="1778328" y="789754"/>
            <a:ext cx="139592" cy="1907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7F4F2DC2-FE14-E676-DFE6-E2FB6EAFE7C1}"/>
              </a:ext>
            </a:extLst>
          </p:cNvPr>
          <p:cNvSpPr txBox="1"/>
          <p:nvPr/>
        </p:nvSpPr>
        <p:spPr>
          <a:xfrm>
            <a:off x="1563953" y="789754"/>
            <a:ext cx="184412" cy="1907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2C0F6B02-855C-4817-E7B5-321857249CB4}"/>
              </a:ext>
            </a:extLst>
          </p:cNvPr>
          <p:cNvSpPr txBox="1"/>
          <p:nvPr/>
        </p:nvSpPr>
        <p:spPr>
          <a:xfrm>
            <a:off x="1943725" y="1026735"/>
            <a:ext cx="667106" cy="1907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SP43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F7CDCABD-1C24-F7D3-34E1-BA7825408665}"/>
              </a:ext>
            </a:extLst>
          </p:cNvPr>
          <p:cNvSpPr txBox="1"/>
          <p:nvPr/>
        </p:nvSpPr>
        <p:spPr>
          <a:xfrm>
            <a:off x="1950389" y="1739683"/>
            <a:ext cx="537597" cy="1907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CA9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F771F642-48DF-2AAF-293C-A85205830229}"/>
              </a:ext>
            </a:extLst>
          </p:cNvPr>
          <p:cNvSpPr txBox="1"/>
          <p:nvPr/>
        </p:nvSpPr>
        <p:spPr>
          <a:xfrm>
            <a:off x="1950389" y="2082490"/>
            <a:ext cx="450696" cy="1907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F76F4C07-2A3E-18AD-82E0-899C2C6BFF06}"/>
              </a:ext>
            </a:extLst>
          </p:cNvPr>
          <p:cNvSpPr txBox="1"/>
          <p:nvPr/>
        </p:nvSpPr>
        <p:spPr>
          <a:xfrm>
            <a:off x="1950389" y="1407249"/>
            <a:ext cx="446721" cy="1907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-1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DC955FEE-3B96-A577-9BA2-BF32FBB2E9EC}"/>
              </a:ext>
            </a:extLst>
          </p:cNvPr>
          <p:cNvSpPr txBox="1"/>
          <p:nvPr/>
        </p:nvSpPr>
        <p:spPr>
          <a:xfrm>
            <a:off x="2061954" y="490300"/>
            <a:ext cx="677235" cy="1907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Mock siRNA</a:t>
            </a: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6CDD1CBA-3E3A-D0C3-2714-D3E04B51742F}"/>
              </a:ext>
            </a:extLst>
          </p:cNvPr>
          <p:cNvSpPr txBox="1"/>
          <p:nvPr/>
        </p:nvSpPr>
        <p:spPr>
          <a:xfrm>
            <a:off x="924568" y="486154"/>
            <a:ext cx="184412" cy="1907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915399B2-7392-2290-05EF-100063EF936C}"/>
              </a:ext>
            </a:extLst>
          </p:cNvPr>
          <p:cNvSpPr txBox="1"/>
          <p:nvPr/>
        </p:nvSpPr>
        <p:spPr>
          <a:xfrm>
            <a:off x="1329145" y="486154"/>
            <a:ext cx="139592" cy="1907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07F725A4-25D5-1CC3-31F9-E961571AA291}"/>
              </a:ext>
            </a:extLst>
          </p:cNvPr>
          <p:cNvSpPr txBox="1"/>
          <p:nvPr/>
        </p:nvSpPr>
        <p:spPr>
          <a:xfrm>
            <a:off x="1138945" y="486154"/>
            <a:ext cx="184412" cy="1907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EFDD87B5-E002-C6B4-768C-38978C6E1852}"/>
              </a:ext>
            </a:extLst>
          </p:cNvPr>
          <p:cNvSpPr txBox="1"/>
          <p:nvPr/>
        </p:nvSpPr>
        <p:spPr>
          <a:xfrm>
            <a:off x="711934" y="486154"/>
            <a:ext cx="139592" cy="1907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04FC0856-E4F0-01BD-8D25-E2462D4DCEFB}"/>
              </a:ext>
            </a:extLst>
          </p:cNvPr>
          <p:cNvSpPr txBox="1"/>
          <p:nvPr/>
        </p:nvSpPr>
        <p:spPr>
          <a:xfrm>
            <a:off x="1563804" y="486154"/>
            <a:ext cx="184412" cy="1907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05B0028D-8CE6-006E-39E3-6BF8E60E4DFC}"/>
              </a:ext>
            </a:extLst>
          </p:cNvPr>
          <p:cNvSpPr txBox="1"/>
          <p:nvPr/>
        </p:nvSpPr>
        <p:spPr>
          <a:xfrm>
            <a:off x="1778179" y="486154"/>
            <a:ext cx="184412" cy="1907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F9CFAA74-2560-81BA-2468-FF48A63B7E4A}"/>
              </a:ext>
            </a:extLst>
          </p:cNvPr>
          <p:cNvSpPr txBox="1"/>
          <p:nvPr/>
        </p:nvSpPr>
        <p:spPr>
          <a:xfrm>
            <a:off x="325409" y="759362"/>
            <a:ext cx="322190" cy="1907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102AEDCF-38E9-1712-76BF-1A88748E49D9}"/>
              </a:ext>
            </a:extLst>
          </p:cNvPr>
          <p:cNvSpPr txBox="1"/>
          <p:nvPr/>
        </p:nvSpPr>
        <p:spPr>
          <a:xfrm>
            <a:off x="320614" y="937567"/>
            <a:ext cx="283265" cy="1734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48</a:t>
            </a: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F7B186B7-EF9D-4904-C9D8-00805C8625C6}"/>
              </a:ext>
            </a:extLst>
          </p:cNvPr>
          <p:cNvSpPr txBox="1"/>
          <p:nvPr/>
        </p:nvSpPr>
        <p:spPr>
          <a:xfrm>
            <a:off x="368789" y="1402101"/>
            <a:ext cx="235091" cy="1734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98</a:t>
            </a: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01FB36E2-8954-67B6-50EB-8D25792C4E6A}"/>
              </a:ext>
            </a:extLst>
          </p:cNvPr>
          <p:cNvSpPr txBox="1"/>
          <p:nvPr/>
        </p:nvSpPr>
        <p:spPr>
          <a:xfrm>
            <a:off x="368789" y="1802666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CACB659C-9A80-E3FD-685C-A2EC41559F40}"/>
              </a:ext>
            </a:extLst>
          </p:cNvPr>
          <p:cNvSpPr txBox="1"/>
          <p:nvPr/>
        </p:nvSpPr>
        <p:spPr>
          <a:xfrm>
            <a:off x="368789" y="2141303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cxnSp>
        <p:nvCxnSpPr>
          <p:cNvPr id="88" name="Straight Connector 87">
            <a:extLst>
              <a:ext uri="{FF2B5EF4-FFF2-40B4-BE49-F238E27FC236}">
                <a16:creationId xmlns:a16="http://schemas.microsoft.com/office/drawing/2014/main" id="{3A4FA148-297A-FA20-3FF0-B39757EC94E4}"/>
              </a:ext>
            </a:extLst>
          </p:cNvPr>
          <p:cNvCxnSpPr/>
          <p:nvPr/>
        </p:nvCxnSpPr>
        <p:spPr>
          <a:xfrm>
            <a:off x="622069" y="1055195"/>
            <a:ext cx="571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9" name="Straight Connector 88">
            <a:extLst>
              <a:ext uri="{FF2B5EF4-FFF2-40B4-BE49-F238E27FC236}">
                <a16:creationId xmlns:a16="http://schemas.microsoft.com/office/drawing/2014/main" id="{E5344E1F-5389-5665-9B82-4A4E8E9B4B65}"/>
              </a:ext>
            </a:extLst>
          </p:cNvPr>
          <p:cNvCxnSpPr/>
          <p:nvPr/>
        </p:nvCxnSpPr>
        <p:spPr>
          <a:xfrm>
            <a:off x="622069" y="1512423"/>
            <a:ext cx="571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0" name="Straight Connector 89">
            <a:extLst>
              <a:ext uri="{FF2B5EF4-FFF2-40B4-BE49-F238E27FC236}">
                <a16:creationId xmlns:a16="http://schemas.microsoft.com/office/drawing/2014/main" id="{C37A5A5D-B6B0-38C9-0ADA-A41977D3F07B}"/>
              </a:ext>
            </a:extLst>
          </p:cNvPr>
          <p:cNvCxnSpPr/>
          <p:nvPr/>
        </p:nvCxnSpPr>
        <p:spPr>
          <a:xfrm>
            <a:off x="622069" y="1914033"/>
            <a:ext cx="571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1" name="Straight Connector 90">
            <a:extLst>
              <a:ext uri="{FF2B5EF4-FFF2-40B4-BE49-F238E27FC236}">
                <a16:creationId xmlns:a16="http://schemas.microsoft.com/office/drawing/2014/main" id="{A622721A-889F-2566-B964-96EC373BBDEA}"/>
              </a:ext>
            </a:extLst>
          </p:cNvPr>
          <p:cNvCxnSpPr/>
          <p:nvPr/>
        </p:nvCxnSpPr>
        <p:spPr>
          <a:xfrm>
            <a:off x="626547" y="2253632"/>
            <a:ext cx="571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92" name="Picture 91">
            <a:extLst>
              <a:ext uri="{FF2B5EF4-FFF2-40B4-BE49-F238E27FC236}">
                <a16:creationId xmlns:a16="http://schemas.microsoft.com/office/drawing/2014/main" id="{65FADD15-5ECE-4EE7-2D9D-B882A4F42297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1" t="-538" r="590" b="523"/>
          <a:stretch/>
        </p:blipFill>
        <p:spPr>
          <a:xfrm rot="5400000">
            <a:off x="3735785" y="-419674"/>
            <a:ext cx="2158765" cy="327435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3" name="Picture 92">
            <a:extLst>
              <a:ext uri="{FF2B5EF4-FFF2-40B4-BE49-F238E27FC236}">
                <a16:creationId xmlns:a16="http://schemas.microsoft.com/office/drawing/2014/main" id="{14FB4D59-A118-4C11-D6B1-9D2EC0789A84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85" t="-30" r="13" b="-321"/>
          <a:stretch/>
        </p:blipFill>
        <p:spPr>
          <a:xfrm rot="5400000">
            <a:off x="7003435" y="-182775"/>
            <a:ext cx="2669617" cy="340339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4" name="Picture 93">
            <a:extLst>
              <a:ext uri="{FF2B5EF4-FFF2-40B4-BE49-F238E27FC236}">
                <a16:creationId xmlns:a16="http://schemas.microsoft.com/office/drawing/2014/main" id="{BE8CBC0F-97DA-0776-AF57-99DDF149139D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077" t="-1053" r="1570" b="-367"/>
          <a:stretch/>
        </p:blipFill>
        <p:spPr>
          <a:xfrm rot="5400000">
            <a:off x="3361168" y="2289326"/>
            <a:ext cx="2879908" cy="312637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96" name="Rectangle 95">
            <a:extLst>
              <a:ext uri="{FF2B5EF4-FFF2-40B4-BE49-F238E27FC236}">
                <a16:creationId xmlns:a16="http://schemas.microsoft.com/office/drawing/2014/main" id="{E44AA697-1CE5-8379-3107-0792547DEEEF}"/>
              </a:ext>
            </a:extLst>
          </p:cNvPr>
          <p:cNvSpPr/>
          <p:nvPr/>
        </p:nvSpPr>
        <p:spPr>
          <a:xfrm>
            <a:off x="3679205" y="466703"/>
            <a:ext cx="737508" cy="20452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7" name="Rectangle 96">
            <a:extLst>
              <a:ext uri="{FF2B5EF4-FFF2-40B4-BE49-F238E27FC236}">
                <a16:creationId xmlns:a16="http://schemas.microsoft.com/office/drawing/2014/main" id="{C4455EAC-E3DE-9A43-4515-0576D29C9928}"/>
              </a:ext>
            </a:extLst>
          </p:cNvPr>
          <p:cNvSpPr/>
          <p:nvPr/>
        </p:nvSpPr>
        <p:spPr>
          <a:xfrm>
            <a:off x="7118773" y="635118"/>
            <a:ext cx="737508" cy="20452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8" name="Rectangle 97">
            <a:extLst>
              <a:ext uri="{FF2B5EF4-FFF2-40B4-BE49-F238E27FC236}">
                <a16:creationId xmlns:a16="http://schemas.microsoft.com/office/drawing/2014/main" id="{73718850-9E0A-175B-B720-615BFC72000C}"/>
              </a:ext>
            </a:extLst>
          </p:cNvPr>
          <p:cNvSpPr/>
          <p:nvPr/>
        </p:nvSpPr>
        <p:spPr>
          <a:xfrm>
            <a:off x="4889923" y="2694320"/>
            <a:ext cx="737508" cy="20452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9" name="Rectangle 98">
            <a:extLst>
              <a:ext uri="{FF2B5EF4-FFF2-40B4-BE49-F238E27FC236}">
                <a16:creationId xmlns:a16="http://schemas.microsoft.com/office/drawing/2014/main" id="{190B6794-9D31-5A8F-DE0A-E4B52C2732FB}"/>
              </a:ext>
            </a:extLst>
          </p:cNvPr>
          <p:cNvSpPr/>
          <p:nvPr/>
        </p:nvSpPr>
        <p:spPr>
          <a:xfrm>
            <a:off x="4887765" y="2883680"/>
            <a:ext cx="737508" cy="204524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00" name="TextBox 99">
            <a:extLst>
              <a:ext uri="{FF2B5EF4-FFF2-40B4-BE49-F238E27FC236}">
                <a16:creationId xmlns:a16="http://schemas.microsoft.com/office/drawing/2014/main" id="{7C7A4E9E-B63E-B158-A4AF-8FAC408A1DA8}"/>
              </a:ext>
            </a:extLst>
          </p:cNvPr>
          <p:cNvSpPr txBox="1"/>
          <p:nvPr/>
        </p:nvSpPr>
        <p:spPr>
          <a:xfrm>
            <a:off x="4375247" y="458102"/>
            <a:ext cx="667106" cy="1907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SP43</a:t>
            </a:r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id="{15CF31AB-BF24-7A27-2B78-75AA943AF5E2}"/>
              </a:ext>
            </a:extLst>
          </p:cNvPr>
          <p:cNvSpPr txBox="1"/>
          <p:nvPr/>
        </p:nvSpPr>
        <p:spPr>
          <a:xfrm>
            <a:off x="6654299" y="610814"/>
            <a:ext cx="446721" cy="1907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-1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id="{818CD389-CF50-4935-26CA-7EEE0FF5D6B6}"/>
              </a:ext>
            </a:extLst>
          </p:cNvPr>
          <p:cNvSpPr txBox="1"/>
          <p:nvPr/>
        </p:nvSpPr>
        <p:spPr>
          <a:xfrm>
            <a:off x="5628709" y="2672622"/>
            <a:ext cx="537597" cy="1907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CA9</a:t>
            </a:r>
          </a:p>
        </p:txBody>
      </p:sp>
      <p:sp>
        <p:nvSpPr>
          <p:cNvPr id="103" name="TextBox 102">
            <a:extLst>
              <a:ext uri="{FF2B5EF4-FFF2-40B4-BE49-F238E27FC236}">
                <a16:creationId xmlns:a16="http://schemas.microsoft.com/office/drawing/2014/main" id="{A346117B-CEB7-3254-9D97-38648BCD9EE4}"/>
              </a:ext>
            </a:extLst>
          </p:cNvPr>
          <p:cNvSpPr txBox="1"/>
          <p:nvPr/>
        </p:nvSpPr>
        <p:spPr>
          <a:xfrm>
            <a:off x="5645304" y="2869216"/>
            <a:ext cx="450696" cy="1907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</a:p>
        </p:txBody>
      </p:sp>
    </p:spTree>
    <p:extLst>
      <p:ext uri="{BB962C8B-B14F-4D97-AF65-F5344CB8AC3E}">
        <p14:creationId xmlns:p14="http://schemas.microsoft.com/office/powerpoint/2010/main" val="8893368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2</TotalTime>
  <Words>142</Words>
  <Application>Microsoft Office PowerPoint</Application>
  <PresentationFormat>Widescreen</PresentationFormat>
  <Paragraphs>103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ptos</vt:lpstr>
      <vt:lpstr>Aptos Display</vt:lpstr>
      <vt:lpstr>Arial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ekle Pauzaite</dc:creator>
  <cp:lastModifiedBy>Tekle Pauzaite</cp:lastModifiedBy>
  <cp:revision>1</cp:revision>
  <dcterms:created xsi:type="dcterms:W3CDTF">2024-05-20T08:14:05Z</dcterms:created>
  <dcterms:modified xsi:type="dcterms:W3CDTF">2024-05-20T08:46:42Z</dcterms:modified>
</cp:coreProperties>
</file>